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8" r:id="rId2"/>
    <p:sldId id="260" r:id="rId3"/>
    <p:sldId id="264" r:id="rId4"/>
    <p:sldId id="26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3400751-ECEF-5C0A-E487-D91011D74E53}" name="丹伊田　拓磨" initials="丹伊田　拓磨" userId="丹伊田　拓磨" providerId="None"/>
  <p188:author id="{D8305098-D383-EF55-66E6-CD77EAB6E5B6}" name="丹伊田 拓磨" initials="丹伊田" userId="1e035ea1314ef093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3003" autoAdjust="0"/>
    <p:restoredTop sz="93692"/>
  </p:normalViewPr>
  <p:slideViewPr>
    <p:cSldViewPr snapToGrid="0">
      <p:cViewPr varScale="1">
        <p:scale>
          <a:sx n="122" d="100"/>
          <a:sy n="122" d="100"/>
        </p:scale>
        <p:origin x="13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9EA7C3-CB25-454F-A8C5-74384A43889A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72812A-E06D-4892-B1C5-AF5394CB2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7611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465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263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4275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211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575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11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336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0225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673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650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7658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8F5CA-81EC-497B-BF1B-505DA6777995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236EE-9921-4609-A1F0-2002A20613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6442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10F671A4-3C7B-4BA1-9C45-3A56BA5291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3063001"/>
              </p:ext>
            </p:extLst>
          </p:nvPr>
        </p:nvGraphicFramePr>
        <p:xfrm>
          <a:off x="174626" y="995462"/>
          <a:ext cx="6508747" cy="1767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31875">
                  <a:extLst>
                    <a:ext uri="{9D8B030D-6E8A-4147-A177-3AD203B41FA5}">
                      <a16:colId xmlns:a16="http://schemas.microsoft.com/office/drawing/2014/main" val="1188931719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439076973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940537830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3137316485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1656068789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2903742551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3789018856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1955734059"/>
                    </a:ext>
                  </a:extLst>
                </a:gridCol>
                <a:gridCol w="684609">
                  <a:extLst>
                    <a:ext uri="{9D8B030D-6E8A-4147-A177-3AD203B41FA5}">
                      <a16:colId xmlns:a16="http://schemas.microsoft.com/office/drawing/2014/main" val="2436358729"/>
                    </a:ext>
                  </a:extLst>
                </a:gridCol>
              </a:tblGrid>
              <a:tr h="0">
                <a:tc rowSpan="3"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rimming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Genomic sequences 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ranscript sequences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912053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/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Forward  reads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Reverse reads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Forward reads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Reverse reads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200801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Trimming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Before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After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Before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After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Before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After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Before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After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66157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Total sequences (n)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330,675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88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327,183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843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330,675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88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327,183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843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31,361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556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9,595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93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31,361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556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9,595,</a:t>
                      </a:r>
                    </a:p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932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79955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Sequence length (bp)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151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15-150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151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15-150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101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15-100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101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15-1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9802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GC (%)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6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7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7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27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44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44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42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Helvetica" pitchFamily="2" charset="0"/>
                        </a:rPr>
                        <a:t>4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9401810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9143683-2F72-4579-AFBC-D85E321781C6}"/>
              </a:ext>
            </a:extLst>
          </p:cNvPr>
          <p:cNvSpPr txBox="1"/>
          <p:nvPr/>
        </p:nvSpPr>
        <p:spPr>
          <a:xfrm>
            <a:off x="174626" y="558654"/>
            <a:ext cx="20129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494180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8451173-DD0C-954C-A28A-9303D8DC77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3370226"/>
              </p:ext>
            </p:extLst>
          </p:nvPr>
        </p:nvGraphicFramePr>
        <p:xfrm>
          <a:off x="367248" y="1034846"/>
          <a:ext cx="6123504" cy="195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44324">
                  <a:extLst>
                    <a:ext uri="{9D8B030D-6E8A-4147-A177-3AD203B41FA5}">
                      <a16:colId xmlns:a16="http://schemas.microsoft.com/office/drawing/2014/main" val="2190166628"/>
                    </a:ext>
                  </a:extLst>
                </a:gridCol>
                <a:gridCol w="800986">
                  <a:extLst>
                    <a:ext uri="{9D8B030D-6E8A-4147-A177-3AD203B41FA5}">
                      <a16:colId xmlns:a16="http://schemas.microsoft.com/office/drawing/2014/main" val="1236659520"/>
                    </a:ext>
                  </a:extLst>
                </a:gridCol>
                <a:gridCol w="1899684">
                  <a:extLst>
                    <a:ext uri="{9D8B030D-6E8A-4147-A177-3AD203B41FA5}">
                      <a16:colId xmlns:a16="http://schemas.microsoft.com/office/drawing/2014/main" val="25450501"/>
                    </a:ext>
                  </a:extLst>
                </a:gridCol>
                <a:gridCol w="624781">
                  <a:extLst>
                    <a:ext uri="{9D8B030D-6E8A-4147-A177-3AD203B41FA5}">
                      <a16:colId xmlns:a16="http://schemas.microsoft.com/office/drawing/2014/main" val="2264158325"/>
                    </a:ext>
                  </a:extLst>
                </a:gridCol>
                <a:gridCol w="953729">
                  <a:extLst>
                    <a:ext uri="{9D8B030D-6E8A-4147-A177-3AD203B41FA5}">
                      <a16:colId xmlns:a16="http://schemas.microsoft.com/office/drawing/2014/main" val="433340088"/>
                    </a:ext>
                  </a:extLst>
                </a:gridCol>
              </a:tblGrid>
              <a:tr h="187849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Query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Database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Hi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 value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Aligned  site 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5392551"/>
                  </a:ext>
                </a:extLst>
              </a:tr>
              <a:tr h="187849">
                <a:tc row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Pcha Lw opsin </a:t>
                      </a: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APY20654.1</a:t>
                      </a:r>
                    </a:p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(382 aa)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Genome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scaffold53886_cov147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1e-56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75 - 206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4732660"/>
                  </a:ext>
                </a:extLst>
              </a:tr>
              <a:tr h="187849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scaffold50064_cov13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5e-4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217 - 382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2886398"/>
                  </a:ext>
                </a:extLst>
              </a:tr>
              <a:tr h="187849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scaffold36250_cov15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4e-3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1 - 97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7812256"/>
                  </a:ext>
                </a:extLst>
              </a:tr>
              <a:tr h="187849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Transcript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TRINITY_DN15450_c0_g1_i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1 - 282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480553"/>
                  </a:ext>
                </a:extLst>
              </a:tr>
              <a:tr h="187849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TRINITY_DN4241_c0_g1_i1</a:t>
                      </a: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1e-53</a:t>
                      </a: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278 - 382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4363730"/>
                  </a:ext>
                </a:extLst>
              </a:tr>
              <a:tr h="187849"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Pcha Uv opsin </a:t>
                      </a: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APY20653.1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(385 aa)</a:t>
                      </a: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Genome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scaffold54798_cov158</a:t>
                      </a: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4e-103</a:t>
                      </a: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1 - 341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3313362"/>
                  </a:ext>
                </a:extLst>
              </a:tr>
              <a:tr h="187849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Transcript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No hit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5341791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F79E89-9FEA-F449-B7CB-47F51103D822}"/>
              </a:ext>
            </a:extLst>
          </p:cNvPr>
          <p:cNvSpPr txBox="1"/>
          <p:nvPr/>
        </p:nvSpPr>
        <p:spPr>
          <a:xfrm>
            <a:off x="367248" y="589477"/>
            <a:ext cx="20129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3845103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126FCA7-B638-4551-B414-36CCE8B5BFEB}"/>
              </a:ext>
            </a:extLst>
          </p:cNvPr>
          <p:cNvSpPr txBox="1"/>
          <p:nvPr/>
        </p:nvSpPr>
        <p:spPr>
          <a:xfrm>
            <a:off x="272404" y="602076"/>
            <a:ext cx="2222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Table S3</a:t>
            </a:r>
          </a:p>
        </p:txBody>
      </p:sp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8F216FEB-917E-4AE9-AC22-AAC1DBAB6E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702780"/>
              </p:ext>
            </p:extLst>
          </p:nvPr>
        </p:nvGraphicFramePr>
        <p:xfrm>
          <a:off x="368667" y="1036320"/>
          <a:ext cx="5248797" cy="783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16479">
                  <a:extLst>
                    <a:ext uri="{9D8B030D-6E8A-4147-A177-3AD203B41FA5}">
                      <a16:colId xmlns:a16="http://schemas.microsoft.com/office/drawing/2014/main" val="3819408014"/>
                    </a:ext>
                  </a:extLst>
                </a:gridCol>
                <a:gridCol w="895281">
                  <a:extLst>
                    <a:ext uri="{9D8B030D-6E8A-4147-A177-3AD203B41FA5}">
                      <a16:colId xmlns:a16="http://schemas.microsoft.com/office/drawing/2014/main" val="1412431309"/>
                    </a:ext>
                  </a:extLst>
                </a:gridCol>
                <a:gridCol w="2964115">
                  <a:extLst>
                    <a:ext uri="{9D8B030D-6E8A-4147-A177-3AD203B41FA5}">
                      <a16:colId xmlns:a16="http://schemas.microsoft.com/office/drawing/2014/main" val="2783596080"/>
                    </a:ext>
                  </a:extLst>
                </a:gridCol>
                <a:gridCol w="572922">
                  <a:extLst>
                    <a:ext uri="{9D8B030D-6E8A-4147-A177-3AD203B41FA5}">
                      <a16:colId xmlns:a16="http://schemas.microsoft.com/office/drawing/2014/main" val="2610144525"/>
                    </a:ext>
                  </a:extLst>
                </a:gridCol>
              </a:tblGrid>
              <a:tr h="232202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arge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emplat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Primer sequences 5’-3’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1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 (℃)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838709"/>
                  </a:ext>
                </a:extLst>
              </a:tr>
              <a:tr h="232202">
                <a:tc rowSpan="11">
                  <a:txBody>
                    <a:bodyPr/>
                    <a:lstStyle/>
                    <a:p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lw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opsin</a:t>
                      </a:r>
                      <a:endParaRPr kumimoji="1" lang="ja-JP" altLang="en-US" sz="1000" i="1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1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gDNA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PCR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489184618"/>
                  </a:ext>
                </a:extLst>
              </a:tr>
              <a:tr h="377329">
                <a:tc vMerge="1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lw opsin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gDNA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F: AAGGTCCGCATTTTCACTTG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TCCTCTAGAAGCGCCTTTTAAT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55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2724818"/>
                  </a:ext>
                </a:extLst>
              </a:tr>
              <a:tr h="377329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F: TTGCAAATTTTGGCACTCTG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CCAAAATGTAACTTCGGCTCA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6121593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Cycle Sequencing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9517228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AAGGTCCGCATTTTCACTTG </a:t>
                      </a: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7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50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8152651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TCCTCTAGAAGCGCCTTTTAAT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8008638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TTGCAAATTTTGGCACTCTG 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1069688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CCAAAATGTAACTTCGGCTCA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5699048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ACGATTCGAAGCAATGATGG 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5260637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</a:t>
                      </a:r>
                      <a:r>
                        <a:rPr kumimoji="1" lang="en-US" altLang="ja-JP" sz="1000" b="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</a:rPr>
                        <a:t>CTAGCCCGTGTCCGATAAAA</a:t>
                      </a:r>
                      <a:r>
                        <a:rPr kumimoji="1" lang="en-US" altLang="ja-JP" sz="1000" dirty="0">
                          <a:latin typeface="Helvetica" pitchFamily="2" charset="0"/>
                        </a:rPr>
                        <a:t>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0889772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</a:t>
                      </a:r>
                      <a:r>
                        <a:rPr kumimoji="1" lang="en-US" altLang="ja-JP" sz="1000" b="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</a:rPr>
                        <a:t>GAAACGATGAAATTAGAG</a:t>
                      </a:r>
                      <a:r>
                        <a:rPr kumimoji="1" lang="en-US" altLang="ja-JP" sz="1000" dirty="0">
                          <a:latin typeface="Helvetica" pitchFamily="2" charset="0"/>
                        </a:rPr>
                        <a:t>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383300"/>
                  </a:ext>
                </a:extLst>
              </a:tr>
              <a:tr h="232202">
                <a:tc rowSpan="7">
                  <a:txBody>
                    <a:bodyPr/>
                    <a:lstStyle/>
                    <a:p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lw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opsin</a:t>
                      </a:r>
                      <a:endParaRPr kumimoji="1" lang="ja-JP" altLang="en-US" sz="1000" i="1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7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 cDNA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T-PCR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9225914"/>
                  </a:ext>
                </a:extLst>
              </a:tr>
              <a:tr h="377329">
                <a:tc vMerge="1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lw opsin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 cDNA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F: ATGTGCTGTATGTCTCCCGC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CAGTCGTTCCAGAAACTGCG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55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85048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Cycle Sequencing</a:t>
                      </a:r>
                    </a:p>
                  </a:txBody>
                  <a:tcPr>
                    <a:lnL w="12700" cmpd="sng"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7328559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ATGTGCTGTATGTCTCCCGC </a:t>
                      </a:r>
                    </a:p>
                  </a:txBody>
                  <a:tcPr>
                    <a:lnL w="12700" cmpd="sng">
                      <a:noFill/>
                    </a:lnL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4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50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8563805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TTTGGCACTCTGGGCTTTCT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0034448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CAGTCGTTCCAGAAACTGCG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9169955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GTGTCTTCTGGTGGAGGAGG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L w="12700" cmpd="sng"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229056"/>
                  </a:ext>
                </a:extLst>
              </a:tr>
              <a:tr h="232202">
                <a:tc rowSpan="10">
                  <a:txBody>
                    <a:bodyPr/>
                    <a:lstStyle/>
                    <a:p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uv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opsin</a:t>
                      </a:r>
                      <a:r>
                        <a:rPr kumimoji="1" lang="en-US" altLang="ja-JP" sz="1000" dirty="0">
                          <a:latin typeface="Helvetica" pitchFamily="2" charset="0"/>
                        </a:rPr>
                        <a:t>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10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cDNA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T-PCR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5368816"/>
                  </a:ext>
                </a:extLst>
              </a:tr>
              <a:tr h="377329">
                <a:tc vMerge="1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uv opsin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cDNA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F: AGGGTTGTTCGGAAAATAGTTG   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3sites Adapter Primer (3’ RACE CORE Set)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55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8033757"/>
                  </a:ext>
                </a:extLst>
              </a:tr>
              <a:tr h="37732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CGGGGTGGTTATTTCAAGTC   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3sites Adapter Primer (3’ RACE CORE Set)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53786183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Cycle Sequencing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6589555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CGGGGTGGTTATTTCAAGTC   </a:t>
                      </a: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6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50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7298874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ACCTAGCCTTTTGCGACCTT  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872870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F: TTTTCGTCGCGGTAATTTTC   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 baseline="30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24019001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AATGCTTGATTTCCAAACGC   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2380313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AGAGAGGTAAAACCGCCCAT   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4766863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R: ATCGTGTCCAATCCATAGCC     </a:t>
                      </a:r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34425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953448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2B9EF9E-9635-4E30-A717-FF933C0B964C}"/>
              </a:ext>
            </a:extLst>
          </p:cNvPr>
          <p:cNvSpPr txBox="1"/>
          <p:nvPr/>
        </p:nvSpPr>
        <p:spPr>
          <a:xfrm>
            <a:off x="327423" y="526922"/>
            <a:ext cx="2222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Table S4</a:t>
            </a: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1DE1EC0-B2A7-41F9-8696-66BCB2B920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5412078"/>
              </p:ext>
            </p:extLst>
          </p:nvPr>
        </p:nvGraphicFramePr>
        <p:xfrm>
          <a:off x="491613" y="989392"/>
          <a:ext cx="5722374" cy="243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81548">
                  <a:extLst>
                    <a:ext uri="{9D8B030D-6E8A-4147-A177-3AD203B41FA5}">
                      <a16:colId xmlns:a16="http://schemas.microsoft.com/office/drawing/2014/main" val="2190166628"/>
                    </a:ext>
                  </a:extLst>
                </a:gridCol>
                <a:gridCol w="3038168">
                  <a:extLst>
                    <a:ext uri="{9D8B030D-6E8A-4147-A177-3AD203B41FA5}">
                      <a16:colId xmlns:a16="http://schemas.microsoft.com/office/drawing/2014/main" val="25450501"/>
                    </a:ext>
                  </a:extLst>
                </a:gridCol>
                <a:gridCol w="737420">
                  <a:extLst>
                    <a:ext uri="{9D8B030D-6E8A-4147-A177-3AD203B41FA5}">
                      <a16:colId xmlns:a16="http://schemas.microsoft.com/office/drawing/2014/main" val="2264158325"/>
                    </a:ext>
                  </a:extLst>
                </a:gridCol>
                <a:gridCol w="865238">
                  <a:extLst>
                    <a:ext uri="{9D8B030D-6E8A-4147-A177-3AD203B41FA5}">
                      <a16:colId xmlns:a16="http://schemas.microsoft.com/office/drawing/2014/main" val="433340088"/>
                    </a:ext>
                  </a:extLst>
                </a:gridCol>
              </a:tblGrid>
              <a:tr h="15828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Quer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Hi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 value</a:t>
                      </a:r>
                      <a:endParaRPr kumimoji="1" lang="ja-JP" altLang="en-US" sz="1000" b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Identity (%) 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5392551"/>
                  </a:ext>
                </a:extLst>
              </a:tr>
              <a:tr h="158280">
                <a:tc rowSpan="4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>
                          <a:latin typeface="Helvetica" pitchFamily="2" charset="0"/>
                        </a:rPr>
                        <a:t>Tkuz</a:t>
                      </a:r>
                      <a:r>
                        <a:rPr kumimoji="1" lang="en-US" altLang="ja-JP" sz="1000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dirty="0" err="1">
                          <a:latin typeface="Helvetica" pitchFamily="2" charset="0"/>
                        </a:rPr>
                        <a:t>Lw opsin</a:t>
                      </a:r>
                      <a:endParaRPr kumimoji="1" lang="en-US" altLang="ja-JP" sz="1000" kern="1200" dirty="0">
                        <a:solidFill>
                          <a:schemeClr val="dk1"/>
                        </a:solidFill>
                        <a:effectLst/>
                        <a:latin typeface="Helvetica" pitchFamily="2" charset="0"/>
                        <a:ea typeface="+mn-ea"/>
                        <a:cs typeface="+mn-cs"/>
                      </a:endParaRPr>
                    </a:p>
                    <a:p>
                      <a:r>
                        <a:rPr kumimoji="1" lang="en-US" altLang="ja-JP" sz="1000" dirty="0">
                          <a:latin typeface="Helvetica" pitchFamily="2" charset="0"/>
                        </a:rPr>
                        <a:t>(379 aa)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Pogon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chalce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LW APY20654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89.03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4732660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Thermonect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marmorat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LW ACH56536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9.68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2886398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Gyrin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marinus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LW1 APY20606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9.68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7812256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endParaRPr kumimoji="1" lang="ja-JP" altLang="en-US" sz="100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Tribolium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castaneum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LW NP_001155991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9.37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480553"/>
                  </a:ext>
                </a:extLst>
              </a:tr>
              <a:tr h="158280">
                <a:tc row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>
                          <a:latin typeface="Helvetica" pitchFamily="2" charset="0"/>
                        </a:rPr>
                        <a:t>Tkuz</a:t>
                      </a:r>
                      <a:r>
                        <a:rPr kumimoji="1" lang="en-US" altLang="ja-JP" sz="1000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dirty="0" err="1">
                          <a:latin typeface="Helvetica" pitchFamily="2" charset="0"/>
                        </a:rPr>
                        <a:t>Uv opsin</a:t>
                      </a:r>
                      <a:endParaRPr kumimoji="1" lang="en-US" altLang="ja-JP" sz="1000" kern="1200" dirty="0">
                        <a:solidFill>
                          <a:schemeClr val="dk1"/>
                        </a:solidFill>
                        <a:effectLst/>
                        <a:latin typeface="Helvetica" pitchFamily="2" charset="0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(373 aa)</a:t>
                      </a: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Pogon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chalce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UV APY20653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83.71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3313362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kern="1200" dirty="0">
                        <a:solidFill>
                          <a:schemeClr val="dk1"/>
                        </a:solidFill>
                        <a:effectLst/>
                        <a:latin typeface="Helvetica" pitchFamily="2" charset="0"/>
                        <a:ea typeface="+mn-ea"/>
                        <a:cs typeface="+mn-cs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Thermonect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marmorat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UV1 ACH56537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8.75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083512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kern="1200" dirty="0">
                        <a:solidFill>
                          <a:schemeClr val="dk1"/>
                        </a:solidFill>
                        <a:effectLst/>
                        <a:latin typeface="Helvetica" pitchFamily="2" charset="0"/>
                        <a:ea typeface="+mn-ea"/>
                        <a:cs typeface="+mn-cs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Thermonect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marmorat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UV2 ACH56538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1.27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996290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kern="1200" dirty="0">
                        <a:solidFill>
                          <a:schemeClr val="dk1"/>
                        </a:solidFill>
                        <a:effectLst/>
                        <a:latin typeface="Helvetica" pitchFamily="2" charset="0"/>
                        <a:ea typeface="+mn-ea"/>
                        <a:cs typeface="+mn-cs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Gyrinus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marinus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UV1 APY20608.1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5.60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096970"/>
                  </a:ext>
                </a:extLst>
              </a:tr>
              <a:tr h="158280"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kern="1200" dirty="0">
                        <a:solidFill>
                          <a:schemeClr val="dk1"/>
                        </a:solidFill>
                        <a:effectLst/>
                        <a:latin typeface="Helvetica" pitchFamily="2" charset="0"/>
                        <a:ea typeface="+mn-ea"/>
                        <a:cs typeface="+mn-cs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Tribolium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1" dirty="0" err="1">
                          <a:latin typeface="Helvetica" pitchFamily="2" charset="0"/>
                        </a:rPr>
                        <a:t>castaneum</a:t>
                      </a:r>
                      <a:r>
                        <a:rPr kumimoji="1" lang="en-US" altLang="ja-JP" sz="1000" i="1" dirty="0">
                          <a:latin typeface="Helvetica" pitchFamily="2" charset="0"/>
                        </a:rPr>
                        <a:t> </a:t>
                      </a:r>
                      <a:r>
                        <a:rPr kumimoji="1" lang="en-US" altLang="ja-JP" sz="1000" i="0" dirty="0">
                          <a:latin typeface="Helvetica" pitchFamily="2" charset="0"/>
                        </a:rPr>
                        <a:t>UV isoform x1  XP_970344.2</a:t>
                      </a:r>
                      <a:endParaRPr kumimoji="1" lang="ja-JP" altLang="en-US" sz="1000" i="0" dirty="0">
                        <a:latin typeface="Helvetica" pitchFamily="2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0.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Helvetica" pitchFamily="2" charset="0"/>
                        </a:rPr>
                        <a:t>70.67</a:t>
                      </a:r>
                      <a:endParaRPr kumimoji="1" lang="ja-JP" altLang="en-US" sz="1000" dirty="0">
                        <a:latin typeface="Helvetica" pitchFamily="2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35607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5798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24</TotalTime>
  <Words>380</Words>
  <Application>Microsoft Macintosh PowerPoint</Application>
  <PresentationFormat>A4 210 x 297 mm</PresentationFormat>
  <Paragraphs>170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丹伊田　拓磨</dc:creator>
  <cp:lastModifiedBy>skoshikawa</cp:lastModifiedBy>
  <cp:revision>232</cp:revision>
  <dcterms:created xsi:type="dcterms:W3CDTF">2022-07-11T06:19:55Z</dcterms:created>
  <dcterms:modified xsi:type="dcterms:W3CDTF">2023-02-28T10:29:38Z</dcterms:modified>
</cp:coreProperties>
</file>